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EF7C0C7-5742-4D7F-858A-15B49523A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8F852F2-B45E-4C3E-9F50-CD21CE05F4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93F4FC-06FB-4FD8-9704-4F638255F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8ED87F-1213-4693-B2AE-6B0B8D704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7CD603D-E53F-4070-B26D-C96ECB672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13397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4139420-42B6-4339-AB00-75A423210F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7927BE-137A-4F63-9FBC-349D2957FC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3B8065-8FEE-4D37-A938-DF0AC2270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69623F-9F7A-45E8-A242-C3CEA80D03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AB3831E-E5D0-4B8E-B7E1-779EBF4E0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0284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9D085A0-A403-44E8-8A5E-E7BBE70E12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172FED5-F448-4C39-A381-E5D473CB41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4C0D109-E3EC-44BB-8A79-62572968A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A2CF20E-B328-4C1C-8403-057C8EC3B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94C5A0-8038-4EBA-A6AD-01BA48EC7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16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5351B0B-735E-4A15-8FB5-AE3BF16C4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28AA47-D29C-473B-8EA4-46A267DD04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85AD74-36BC-4357-A0A0-F6E316D6A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4FAC9E-653B-4BFD-ABA6-FA7A50E50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E31ED7-D91D-48C5-8C9F-37A2D0C61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76250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CF464CE-CF52-4725-9208-826219D3FD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9E71B12-B434-4D1C-B34A-7D08435CE7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4D63092-37E8-4379-B211-0367F520F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BEF0A05-47AE-4213-A82E-7FCDBCDD2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BC61C4-4496-4EE7-86E2-D061CBA5D4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556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679DC2-1A42-4484-9B95-90E00EBD0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4DFCB15-F9B2-479F-BA64-CA61CC2B386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260F30-D90C-43CC-B22A-01B3AB53C37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32E6486-65B8-48AA-9479-67F22AF75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8AE6FDC-F670-482F-AF1C-693064127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ED5F7B6-2DE4-4A4F-B413-8DD7D9B5B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605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58619A-71D7-4EF7-B422-FB8F917416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E4184D6-BB9D-4B8A-8183-CDCB0F9B3A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C95E14-C612-4370-B837-D6223D70AC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04D2D0D-9176-481B-8599-3F5E7A63E76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F0E21A42-3C18-4344-AF31-C90FE4C774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11323DC-DFDE-4E50-99AC-99B64207B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711A683-6CBE-4DA8-829F-41A9530F8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BC35172-51B9-4078-A237-64E5E9EA3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0315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156A85-24FA-40CE-8535-06FF09B736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3479B20-4983-4A44-AEA7-412E71C7D7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43A50358-B212-49E0-84C0-CF7907B21A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ABE5F662-C48C-4A05-9AD7-97AE12C9E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7220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2307FBAA-A433-4DC8-9B71-B4E5ED4C2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3E986F22-C12F-4494-8AB4-1B8A7D6A5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55BEF92-E259-447E-83E3-72CAC556A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1755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7158BA-DEA5-4872-9763-EEAD285539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A4825A7-3488-41E0-AE51-BF34DDC221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58DF476-1284-4D97-8169-2F9E801F05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2D10B1-2DA4-4C79-8F99-2256B7169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F285620-F5C5-40BF-AD19-3D71DBE509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BF15DA2-158D-440F-8ABF-680FABE8AD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9290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16410-3A6D-4948-8F2D-A7CD62346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00D65EA-8FD6-4B50-A080-5FB5DFF1BD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0724677-F5A9-4CE6-94AC-40D675FEC9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D59B14E-3D22-4A63-92A5-F80028F137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0602ADB-C6F5-4374-BE7D-6F7F83BF4E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EA5DF28-FC9A-456F-A243-5FA12E3A8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215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F34ED60-0E1A-4A2A-8E3D-11676B4F8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8A5D95F-B841-452F-8394-9F9BAD246C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C39724-EF6E-4578-960D-ACA2F41AE83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1E8D2-C8F7-4DB0-BCDB-8F7FF099F5CE}" type="datetimeFigureOut">
              <a:rPr kumimoji="1" lang="ja-JP" altLang="en-US" smtClean="0"/>
              <a:t>2021/11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281AE1F-8642-420D-A6B4-A50EAF056C7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AF870D-27D7-4286-AD40-DB31653340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87C75A-F275-4767-B277-170F9055EB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1083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oup 2">
            <a:extLst>
              <a:ext uri="{FF2B5EF4-FFF2-40B4-BE49-F238E27FC236}">
                <a16:creationId xmlns:a16="http://schemas.microsoft.com/office/drawing/2014/main" id="{71ACB14F-E1BF-40C4-9405-B5BB13298B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4150985"/>
              </p:ext>
            </p:extLst>
          </p:nvPr>
        </p:nvGraphicFramePr>
        <p:xfrm>
          <a:off x="2331309" y="2353908"/>
          <a:ext cx="6601143" cy="8322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380691">
                  <a:extLst>
                    <a:ext uri="{9D8B030D-6E8A-4147-A177-3AD203B41FA5}">
                      <a16:colId xmlns:a16="http://schemas.microsoft.com/office/drawing/2014/main" val="3986917918"/>
                    </a:ext>
                  </a:extLst>
                </a:gridCol>
                <a:gridCol w="9633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2317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14961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842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41956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Target</a:t>
                      </a:r>
                      <a:endParaRPr kumimoji="0" lang="ja-JP" altLang="en-US" sz="11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Gene</a:t>
                      </a: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abbreviation</a:t>
                      </a:r>
                      <a:endParaRPr kumimoji="0" lang="ja-JP" altLang="en-US" sz="11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ja-JP" altLang="en-US" sz="11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sz="28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1pPr>
                      <a:lvl2pPr>
                        <a:spcBef>
                          <a:spcPct val="20000"/>
                        </a:spcBef>
                        <a:defRPr sz="24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2pPr>
                      <a:lvl3pPr>
                        <a:spcBef>
                          <a:spcPct val="20000"/>
                        </a:spcBef>
                        <a:defRPr sz="2000"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3pPr>
                      <a:lvl4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4pPr>
                      <a:lvl5pPr>
                        <a:spcBef>
                          <a:spcPct val="20000"/>
                        </a:spcBef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5pPr>
                      <a:lvl6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6pPr>
                      <a:lvl7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7pPr>
                      <a:lvl8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8pPr>
                      <a:lvl9pPr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>
                          <a:solidFill>
                            <a:schemeClr val="tx1"/>
                          </a:solidFill>
                          <a:latin typeface="Arial" pitchFamily="34" charset="0"/>
                          <a:cs typeface="Arial" pitchFamily="34" charset="0"/>
                        </a:defRPr>
                      </a:lvl9pPr>
                    </a:lstStyle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Nucleotide sequence </a:t>
                      </a:r>
                      <a:r>
                        <a:rPr kumimoji="0" lang="ja-JP" altLang="en-US" sz="110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(5'-3')</a:t>
                      </a:r>
                      <a:endParaRPr kumimoji="0" lang="en-US" altLang="ja-JP" sz="110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Reference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772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Hemoglobin alpha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Hb alpha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Forward</a:t>
                      </a:r>
                      <a:endParaRPr kumimoji="0" lang="ja-JP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750" marR="40500" marT="26325" marB="26325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CTGAAATTGGAGCAGAGGCT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1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This study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444853"/>
                  </a:ext>
                </a:extLst>
              </a:tr>
              <a:tr h="117725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Reverse</a:t>
                      </a:r>
                      <a:endParaRPr kumimoji="0" lang="ja-JP" altLang="en-US" sz="10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Arial Unicode MS" panose="020B060402020202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0750" marR="40500" marT="26325" marB="26325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ja-JP" sz="10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Arial Unicode MS" panose="020B0604020202020204" pitchFamily="50" charset="-128"/>
                          <a:cs typeface="Times New Roman" panose="02020603050405020304" pitchFamily="18" charset="0"/>
                        </a:rPr>
                        <a:t>CTGAGTTTGGTGAGGGCTCC</a:t>
                      </a:r>
                    </a:p>
                  </a:txBody>
                  <a:tcPr marL="50721" marR="50721" marT="26432" marB="26432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52756832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3678009-415D-4417-95A1-A1FAB2727823}"/>
              </a:ext>
            </a:extLst>
          </p:cNvPr>
          <p:cNvSpPr txBox="1"/>
          <p:nvPr/>
        </p:nvSpPr>
        <p:spPr>
          <a:xfrm>
            <a:off x="2264377" y="1962996"/>
            <a:ext cx="71751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723900" indent="-723900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of Hb alpha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ed for quantitative real-time PCR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) 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996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6</Words>
  <Application>Microsoft Office PowerPoint</Application>
  <PresentationFormat>ワイド画面</PresentationFormat>
  <Paragraphs>1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 美里</dc:creator>
  <cp:lastModifiedBy>森 美里</cp:lastModifiedBy>
  <cp:revision>2</cp:revision>
  <dcterms:created xsi:type="dcterms:W3CDTF">2021-11-13T03:42:12Z</dcterms:created>
  <dcterms:modified xsi:type="dcterms:W3CDTF">2021-11-13T03:55:56Z</dcterms:modified>
</cp:coreProperties>
</file>